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72" r:id="rId2"/>
    <p:sldId id="270" r:id="rId3"/>
    <p:sldId id="281" r:id="rId4"/>
    <p:sldId id="275" r:id="rId5"/>
    <p:sldId id="280" r:id="rId6"/>
    <p:sldId id="277" r:id="rId7"/>
    <p:sldId id="279" r:id="rId8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568"/>
    <p:restoredTop sz="95921"/>
  </p:normalViewPr>
  <p:slideViewPr>
    <p:cSldViewPr snapToGrid="0" snapToObjects="1">
      <p:cViewPr varScale="1">
        <p:scale>
          <a:sx n="79" d="100"/>
          <a:sy n="79" d="100"/>
        </p:scale>
        <p:origin x="86" y="22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1450A1-532B-DB41-9F70-5BDA67AA80B8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DD087D-7096-9D42-983C-8A3029A7975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628489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681A86F-336C-EC46-AA5A-82CB3A4EF5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A2B7F17-B962-CF41-BFBD-F533DE91CA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EDA27CE-3721-3649-A39D-F0F9BBC5D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1C9A812-BA1E-F843-B927-F9CD28362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18F02F0-00E8-0940-B90D-33AA006E2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2204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50E9D2D-56B7-2144-AD01-CFE6D1ACE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84E6D46-02AA-5E42-9E79-1B8AE2EBEE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C7F7CD-06DC-0B4E-B013-0F6A26EB9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BD9DCF9-5414-7841-B0C7-C8195AE56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6357559-0C27-9E4B-B748-F9A66DA3C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31437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7345B7D-A141-C44B-898E-1F68979FA4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C1DDA2A-3456-C04C-8E2D-4D30A7702E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84FB0BB-65B4-6344-90C3-7B46D432F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7845F9C-D6A8-F44E-85D1-C42A6664F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9ABE69E-D562-DB43-A518-74627F275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9805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3E8A013-3960-5D43-8191-71018AC6A8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4E5C45D-A2D1-F44F-964F-F0AEE1C79A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CD1743C-6173-2A46-828A-FDA7D1E2A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4B1FC7C-F1FC-6D4A-9727-FBAE4C0E9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D15FDDD-41EA-1D43-8FC8-4A7D27F0E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7123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9FAC53-654E-FD49-A170-35EE2C14BB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0B8E3F2-3A9C-8C48-B493-336B37EE5D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41B1748-6737-0F4F-8F32-303CAE599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E729E20-76A2-4A47-A221-A3FE3D3CCD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D34C89D-5DE2-8C46-875B-EA58D94E1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8079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F020691-5A5F-5641-AF4F-CAA0D5A02E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ACDC119-5215-784D-BB40-FEA68F2C89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F86848A-7CB5-3943-806C-25C14909E7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E9062AA-939C-0A4A-B45D-930EC389D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3A213D9-6E65-3B4E-8432-690544129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CB0A8C4-FAB4-6649-ABCC-F40C4BD59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7053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106F4B9-EC7F-864B-BCA6-351792467B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E82EBA5-3840-F04C-B8AC-C9242B3C97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D00104E-6619-9041-A1FA-030F0DB408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2D9072C-F1A1-F647-9D67-028761F87B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550AC0EF-06F9-344F-8B78-61A68605A0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51695E7E-B18D-3D46-9280-7A1A07E04E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DD6CBA8-55FE-9A43-A43A-2BA334F71C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1A569EBE-97D3-574D-9A2D-876DC0280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5793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4A507D3-9468-6E46-B877-5E6D5BB563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FCAB1B7-E8BA-7041-9D40-90BE802B7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C45E410-B872-C84B-9876-EA01E9D08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2BE4A05-6A9C-8742-BFCF-D04826DE8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3314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E453238F-97DB-7844-854B-7252F1F7D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1C4F7A0-2BAF-B34A-96DA-2ECF94184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A24FD0FF-47E4-614C-AF18-F3A003F94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4938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00C4965-282F-D141-B03F-EDDD8BF17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EAC7D5F-8960-6542-8B9E-A1009972D6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31FE70D-CC75-F048-9963-3B4CD753BA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16E0DAF-9BA9-4948-9F4C-E872DCF3F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B7ACA54-AE53-BF4D-9DF0-72CD83216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7B7B84F-30A9-FA41-B6AB-064844EA52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2255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F8B516B-400D-B64D-B48A-AA70B6967B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9E22B314-E3DB-074F-A342-359FA4E38D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E6CE1AC-1E04-9D49-8819-75FB056B54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15A6F3E-5F8D-2343-8311-975AE0F1E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F75B625-517E-4840-BF1D-2DA0ED0A5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3B23080-A4B5-0A44-BB49-43B91CAD9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920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FFCDE19-4419-2F4E-B510-F2B31368AC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0AFFB51-4A53-8A49-94AB-6DFFFD8997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56F779D-E6EA-784A-9DBA-4B33CA523F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5EE08A-58AD-964C-B80B-97E77A16F9FB}" type="datetimeFigureOut">
              <a:rPr lang="it-IT" smtClean="0"/>
              <a:t>27/07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3953F5F-3C61-344F-AF24-85D1C8AF05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99CDE32-CCCC-CB4F-A1D8-4C3CE8F985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F7F830-3B9D-3545-907F-0006FF685C4E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3872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olo 5">
            <a:extLst>
              <a:ext uri="{FF2B5EF4-FFF2-40B4-BE49-F238E27FC236}">
                <a16:creationId xmlns:a16="http://schemas.microsoft.com/office/drawing/2014/main" id="{FB890204-E7B2-72FC-7B28-6947F5BC9362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0" y="-35569"/>
            <a:ext cx="10515600" cy="7571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: trial sequential analysis (TSA) for the primary endpoint. </a:t>
            </a: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8E1E8E31-2D40-0BB3-8BFB-5F4DABC947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689" y="581416"/>
            <a:ext cx="11625454" cy="6276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2375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D2327936-AF66-DB56-B00E-D228242D34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0"/>
            <a:ext cx="12193188" cy="6858668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AE15A683-9016-6E0D-589F-04C632A7602B}"/>
              </a:ext>
            </a:extLst>
          </p:cNvPr>
          <p:cNvSpPr txBox="1"/>
          <p:nvPr/>
        </p:nvSpPr>
        <p:spPr>
          <a:xfrm>
            <a:off x="-2" y="0"/>
            <a:ext cx="121920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: subgroup analysis of RCTs for the primary endpoint.</a:t>
            </a:r>
          </a:p>
        </p:txBody>
      </p:sp>
    </p:spTree>
    <p:extLst>
      <p:ext uri="{BB962C8B-B14F-4D97-AF65-F5344CB8AC3E}">
        <p14:creationId xmlns:p14="http://schemas.microsoft.com/office/powerpoint/2010/main" val="26964239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magine 7">
            <a:extLst>
              <a:ext uri="{FF2B5EF4-FFF2-40B4-BE49-F238E27FC236}">
                <a16:creationId xmlns:a16="http://schemas.microsoft.com/office/drawing/2014/main" id="{E68581F7-5374-5563-E692-51242ED9FA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" y="230832"/>
            <a:ext cx="12192000" cy="685800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831F02A7-3453-1A33-7D94-AF95B758D7E6}"/>
              </a:ext>
            </a:extLst>
          </p:cNvPr>
          <p:cNvSpPr txBox="1"/>
          <p:nvPr/>
        </p:nvSpPr>
        <p:spPr>
          <a:xfrm>
            <a:off x="-2" y="0"/>
            <a:ext cx="1219200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: Conditional analysis of total number of stents without the study from Kalogeropulos et al, showing a higher number of stents implanted in the IVUS-guided group.</a:t>
            </a:r>
          </a:p>
        </p:txBody>
      </p:sp>
    </p:spTree>
    <p:extLst>
      <p:ext uri="{BB962C8B-B14F-4D97-AF65-F5344CB8AC3E}">
        <p14:creationId xmlns:p14="http://schemas.microsoft.com/office/powerpoint/2010/main" val="33860398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AB03C70D-DFF1-A3A3-6C04-7F1490A4833D}"/>
              </a:ext>
            </a:extLst>
          </p:cNvPr>
          <p:cNvSpPr txBox="1"/>
          <p:nvPr/>
        </p:nvSpPr>
        <p:spPr>
          <a:xfrm>
            <a:off x="7844246" y="6211669"/>
            <a:ext cx="485720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: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ffic light plot for evaluation of risk of bias.</a:t>
            </a:r>
            <a:endParaRPr lang="it-IT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Segnaposto contenuto 8">
            <a:extLst>
              <a:ext uri="{FF2B5EF4-FFF2-40B4-BE49-F238E27FC236}">
                <a16:creationId xmlns:a16="http://schemas.microsoft.com/office/drawing/2014/main" id="{529A11DA-DC21-9380-8C1B-15295D0E1C7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234440" y="91"/>
            <a:ext cx="10121532" cy="5830003"/>
          </a:xfrm>
        </p:spPr>
      </p:pic>
    </p:spTree>
    <p:extLst>
      <p:ext uri="{BB962C8B-B14F-4D97-AF65-F5344CB8AC3E}">
        <p14:creationId xmlns:p14="http://schemas.microsoft.com/office/powerpoint/2010/main" val="25993714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67AB8ECA-7537-36F1-A5AD-28A8C8F2F8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7900" y="365125"/>
            <a:ext cx="6731000" cy="5048250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0FAA41D5-6DFA-E52A-0F84-3B9367D1BCC3}"/>
              </a:ext>
            </a:extLst>
          </p:cNvPr>
          <p:cNvSpPr txBox="1"/>
          <p:nvPr/>
        </p:nvSpPr>
        <p:spPr>
          <a:xfrm>
            <a:off x="43666" y="6488668"/>
            <a:ext cx="1194513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: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 of the primary endpoint (MACE). 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30396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Immagine 39">
            <a:extLst>
              <a:ext uri="{FF2B5EF4-FFF2-40B4-BE49-F238E27FC236}">
                <a16:creationId xmlns:a16="http://schemas.microsoft.com/office/drawing/2014/main" id="{88B1BD53-9C5F-9750-7087-528E94439B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17" y="13732"/>
            <a:ext cx="3657600" cy="2743200"/>
          </a:xfrm>
          <a:prstGeom prst="rect">
            <a:avLst/>
          </a:prstGeom>
        </p:spPr>
      </p:pic>
      <p:pic>
        <p:nvPicPr>
          <p:cNvPr id="31" name="Immagine 30">
            <a:extLst>
              <a:ext uri="{FF2B5EF4-FFF2-40B4-BE49-F238E27FC236}">
                <a16:creationId xmlns:a16="http://schemas.microsoft.com/office/drawing/2014/main" id="{39EA5DCD-F1BC-31C2-454D-22DEA62CE3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38150" y="3613666"/>
            <a:ext cx="3657600" cy="2743200"/>
          </a:xfrm>
          <a:prstGeom prst="rect">
            <a:avLst/>
          </a:prstGeom>
        </p:spPr>
      </p:pic>
      <p:pic>
        <p:nvPicPr>
          <p:cNvPr id="23" name="Immagine 22">
            <a:extLst>
              <a:ext uri="{FF2B5EF4-FFF2-40B4-BE49-F238E27FC236}">
                <a16:creationId xmlns:a16="http://schemas.microsoft.com/office/drawing/2014/main" id="{8F1BA710-7512-9898-262B-FF1AB1471D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65705" y="3824069"/>
            <a:ext cx="3657600" cy="2743200"/>
          </a:xfrm>
          <a:prstGeom prst="rect">
            <a:avLst/>
          </a:prstGeom>
        </p:spPr>
      </p:pic>
      <p:pic>
        <p:nvPicPr>
          <p:cNvPr id="21" name="Immagine 20">
            <a:extLst>
              <a:ext uri="{FF2B5EF4-FFF2-40B4-BE49-F238E27FC236}">
                <a16:creationId xmlns:a16="http://schemas.microsoft.com/office/drawing/2014/main" id="{A49E5FCC-AFA2-2F78-E310-4245F831B6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58994" y="52169"/>
            <a:ext cx="3657600" cy="2743200"/>
          </a:xfrm>
          <a:prstGeom prst="rect">
            <a:avLst/>
          </a:prstGeom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5ABE4DCB-7C4A-6E3A-209B-DF2DEEA7EBD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3824069"/>
            <a:ext cx="3657600" cy="2743200"/>
          </a:xfrm>
          <a:prstGeom prst="rect">
            <a:avLst/>
          </a:prstGeom>
        </p:spPr>
      </p:pic>
      <p:pic>
        <p:nvPicPr>
          <p:cNvPr id="25" name="Immagine 24">
            <a:extLst>
              <a:ext uri="{FF2B5EF4-FFF2-40B4-BE49-F238E27FC236}">
                <a16:creationId xmlns:a16="http://schemas.microsoft.com/office/drawing/2014/main" id="{97F8AE55-233E-8F6D-772A-BBC51125E5E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16594" y="52169"/>
            <a:ext cx="3657600" cy="2743200"/>
          </a:xfrm>
          <a:prstGeom prst="rect">
            <a:avLst/>
          </a:prstGeom>
        </p:spPr>
      </p:pic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8E76F817-75B8-2B8B-7B78-9DF2311CBA3F}"/>
              </a:ext>
            </a:extLst>
          </p:cNvPr>
          <p:cNvSpPr txBox="1"/>
          <p:nvPr/>
        </p:nvSpPr>
        <p:spPr>
          <a:xfrm>
            <a:off x="43666" y="6488668"/>
            <a:ext cx="1194513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: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s of all-cause mortality (A), CV death (B), MI (C), TVR (D), TLR (E) and stent thrombosis (F). 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CBA3DFC0-51C5-988C-1816-36374F02490D}"/>
              </a:ext>
            </a:extLst>
          </p:cNvPr>
          <p:cNvSpPr txBox="1"/>
          <p:nvPr/>
        </p:nvSpPr>
        <p:spPr>
          <a:xfrm>
            <a:off x="43666" y="-12700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8C3B4E4F-2446-37CC-AEBE-DFEC0A40CB0F}"/>
              </a:ext>
            </a:extLst>
          </p:cNvPr>
          <p:cNvSpPr txBox="1"/>
          <p:nvPr/>
        </p:nvSpPr>
        <p:spPr>
          <a:xfrm>
            <a:off x="43666" y="3244334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B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79AD96EB-3632-040A-A24F-88B2B805423A}"/>
              </a:ext>
            </a:extLst>
          </p:cNvPr>
          <p:cNvSpPr txBox="1"/>
          <p:nvPr/>
        </p:nvSpPr>
        <p:spPr>
          <a:xfrm>
            <a:off x="3485281" y="-12700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C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B3BE6A50-1316-C7BC-95AF-F413FE4749D8}"/>
              </a:ext>
            </a:extLst>
          </p:cNvPr>
          <p:cNvSpPr txBox="1"/>
          <p:nvPr/>
        </p:nvSpPr>
        <p:spPr>
          <a:xfrm>
            <a:off x="3629879" y="3244334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D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F0A45103-8D1D-C34B-39F0-CF5A82A7C118}"/>
              </a:ext>
            </a:extLst>
          </p:cNvPr>
          <p:cNvSpPr txBox="1"/>
          <p:nvPr/>
        </p:nvSpPr>
        <p:spPr>
          <a:xfrm>
            <a:off x="7125055" y="26769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E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B6FFB8E6-DD57-9403-C28E-4BB31F72D016}"/>
              </a:ext>
            </a:extLst>
          </p:cNvPr>
          <p:cNvSpPr txBox="1"/>
          <p:nvPr/>
        </p:nvSpPr>
        <p:spPr>
          <a:xfrm>
            <a:off x="6857718" y="3244334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/>
              <a:t>F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40098571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magine 12">
            <a:extLst>
              <a:ext uri="{FF2B5EF4-FFF2-40B4-BE49-F238E27FC236}">
                <a16:creationId xmlns:a16="http://schemas.microsoft.com/office/drawing/2014/main" id="{31135A44-75A3-6338-CDB3-F2D29410F0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94700" y="3244333"/>
            <a:ext cx="3797300" cy="2847975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67325AC7-400D-5C47-D597-856A64C08A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90734" y="26769"/>
            <a:ext cx="3657600" cy="2743200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4E41FAFA-6E5B-FC7D-53ED-9D812871146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06316" y="3343017"/>
            <a:ext cx="3657600" cy="2743200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14091A4A-5BF1-3552-0A99-C7AD57D8DF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25533" y="0"/>
            <a:ext cx="3657600" cy="2743200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52F5DDA8-3E15-591E-E944-9594D5BE417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666" y="3244334"/>
            <a:ext cx="3657600" cy="2743200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93AF6733-59F3-C64B-388F-ED2932943B6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26769"/>
            <a:ext cx="3657600" cy="2743200"/>
          </a:xfrm>
          <a:prstGeom prst="rect">
            <a:avLst/>
          </a:prstGeom>
        </p:spPr>
      </p:pic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8E76F817-75B8-2B8B-7B78-9DF2311CBA3F}"/>
              </a:ext>
            </a:extLst>
          </p:cNvPr>
          <p:cNvSpPr txBox="1"/>
          <p:nvPr/>
        </p:nvSpPr>
        <p:spPr>
          <a:xfrm>
            <a:off x="43666" y="6184900"/>
            <a:ext cx="11983234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7: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nel plots of stent length (A), stent diameter (B), number of stents (C), procedure time (D), fluoroscopy time (E) and contrast volume (F). 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CBA3DFC0-51C5-988C-1816-36374F02490D}"/>
              </a:ext>
            </a:extLst>
          </p:cNvPr>
          <p:cNvSpPr txBox="1"/>
          <p:nvPr/>
        </p:nvSpPr>
        <p:spPr>
          <a:xfrm>
            <a:off x="43666" y="-12700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8C3B4E4F-2446-37CC-AEBE-DFEC0A40CB0F}"/>
              </a:ext>
            </a:extLst>
          </p:cNvPr>
          <p:cNvSpPr txBox="1"/>
          <p:nvPr/>
        </p:nvSpPr>
        <p:spPr>
          <a:xfrm>
            <a:off x="43666" y="3244334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B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79AD96EB-3632-040A-A24F-88B2B805423A}"/>
              </a:ext>
            </a:extLst>
          </p:cNvPr>
          <p:cNvSpPr txBox="1"/>
          <p:nvPr/>
        </p:nvSpPr>
        <p:spPr>
          <a:xfrm>
            <a:off x="4406316" y="0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C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B3BE6A50-1316-C7BC-95AF-F413FE4749D8}"/>
              </a:ext>
            </a:extLst>
          </p:cNvPr>
          <p:cNvSpPr txBox="1"/>
          <p:nvPr/>
        </p:nvSpPr>
        <p:spPr>
          <a:xfrm>
            <a:off x="4406315" y="3244334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D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F0A45103-8D1D-C34B-39F0-CF5A82A7C118}"/>
              </a:ext>
            </a:extLst>
          </p:cNvPr>
          <p:cNvSpPr txBox="1"/>
          <p:nvPr/>
        </p:nvSpPr>
        <p:spPr>
          <a:xfrm>
            <a:off x="8512121" y="0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E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B6FFB8E6-DD57-9403-C28E-4BB31F72D016}"/>
              </a:ext>
            </a:extLst>
          </p:cNvPr>
          <p:cNvSpPr txBox="1"/>
          <p:nvPr/>
        </p:nvSpPr>
        <p:spPr>
          <a:xfrm>
            <a:off x="8621379" y="3250167"/>
            <a:ext cx="295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/>
              <a:t>F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18756265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76</TotalTime>
  <Words>172</Words>
  <Application>Microsoft Office PowerPoint</Application>
  <PresentationFormat>Widescreen</PresentationFormat>
  <Paragraphs>1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ema di Office</vt:lpstr>
      <vt:lpstr>Supplementary Figure S1: trial sequential analysis (TSA) for the primary endpoint.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Panuccio</dc:creator>
  <cp:lastModifiedBy>MDPI</cp:lastModifiedBy>
  <cp:revision>74</cp:revision>
  <dcterms:created xsi:type="dcterms:W3CDTF">2021-12-01T09:21:19Z</dcterms:created>
  <dcterms:modified xsi:type="dcterms:W3CDTF">2023-07-27T10:42:26Z</dcterms:modified>
</cp:coreProperties>
</file>